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6264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938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0729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389637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4643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3368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84607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49644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53225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4183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62865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96F79-BB88-4E55-8653-C288849D7F93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F563B-9D04-4D2F-A091-8FF1F62243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6585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130109" y="50521"/>
            <a:ext cx="11973059" cy="946878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J-tree &amp; PCA between 271 </a:t>
            </a:r>
            <a:r>
              <a:rPr lang="en-US" sz="3200" i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pomoea batatas </a:t>
            </a:r>
            <a:r>
              <a:rPr lang="en-GB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ccessions </a:t>
            </a:r>
            <a:r>
              <a:rPr lang="en-US" sz="320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mputed with 7,591  polymorphic  SNPs based on countries</a:t>
            </a:r>
            <a:endParaRPr lang="en-GB" sz="3200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03604" y="1461592"/>
            <a:ext cx="5699564" cy="5219295"/>
          </a:xfrm>
          <a:prstGeom prst="rect">
            <a:avLst/>
          </a:prstGeom>
        </p:spPr>
      </p:pic>
      <p:grpSp>
        <p:nvGrpSpPr>
          <p:cNvPr id="7" name="Group 6"/>
          <p:cNvGrpSpPr/>
          <p:nvPr/>
        </p:nvGrpSpPr>
        <p:grpSpPr>
          <a:xfrm>
            <a:off x="6443031" y="1486141"/>
            <a:ext cx="5294554" cy="4914304"/>
            <a:chOff x="6443031" y="1486141"/>
            <a:chExt cx="5294554" cy="4914304"/>
          </a:xfrm>
        </p:grpSpPr>
        <p:sp>
          <p:nvSpPr>
            <p:cNvPr id="8" name="Oval 7"/>
            <p:cNvSpPr/>
            <p:nvPr/>
          </p:nvSpPr>
          <p:spPr>
            <a:xfrm rot="18975307">
              <a:off x="7973407" y="1486141"/>
              <a:ext cx="3764178" cy="4160646"/>
            </a:xfrm>
            <a:prstGeom prst="ellipse">
              <a:avLst/>
            </a:prstGeom>
            <a:solidFill>
              <a:srgbClr val="7030A0">
                <a:alpha val="1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9" name="Oval 8"/>
            <p:cNvSpPr/>
            <p:nvPr/>
          </p:nvSpPr>
          <p:spPr>
            <a:xfrm rot="18975307">
              <a:off x="6443031" y="2239799"/>
              <a:ext cx="2144052" cy="4160646"/>
            </a:xfrm>
            <a:prstGeom prst="ellipse">
              <a:avLst/>
            </a:prstGeom>
            <a:solidFill>
              <a:srgbClr val="0000FF">
                <a:alpha val="17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0" name="Oval 9"/>
            <p:cNvSpPr/>
            <p:nvPr/>
          </p:nvSpPr>
          <p:spPr>
            <a:xfrm rot="18975307">
              <a:off x="8772854" y="4465378"/>
              <a:ext cx="595097" cy="721076"/>
            </a:xfrm>
            <a:prstGeom prst="ellipse">
              <a:avLst/>
            </a:prstGeom>
            <a:solidFill>
              <a:srgbClr val="FFFF00">
                <a:alpha val="29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1" name="Rectangle 10"/>
          <p:cNvSpPr/>
          <p:nvPr/>
        </p:nvSpPr>
        <p:spPr>
          <a:xfrm>
            <a:off x="5481619" y="5297012"/>
            <a:ext cx="1364476" cy="147732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FF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Benin</a:t>
            </a:r>
          </a:p>
          <a:p>
            <a:r>
              <a:rPr lang="en-US" b="1" dirty="0">
                <a:solidFill>
                  <a:srgbClr val="33CC33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Mozambique</a:t>
            </a:r>
          </a:p>
          <a:p>
            <a:r>
              <a:rPr lang="en-US" b="1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iger </a:t>
            </a:r>
          </a:p>
          <a:p>
            <a:r>
              <a:rPr lang="en-US" b="1" dirty="0">
                <a:solidFill>
                  <a:srgbClr val="0000FF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igeria</a:t>
            </a:r>
          </a:p>
          <a:p>
            <a:r>
              <a:rPr lang="en-US" b="1" dirty="0">
                <a:solidFill>
                  <a:schemeClr val="accent4">
                    <a:lumMod val="60000"/>
                    <a:lumOff val="40000"/>
                  </a:schemeClr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Uganda </a:t>
            </a:r>
            <a:endParaRPr lang="en-GB" b="1" dirty="0">
              <a:solidFill>
                <a:schemeClr val="accent4">
                  <a:lumMod val="60000"/>
                  <a:lumOff val="40000"/>
                </a:schemeClr>
              </a:solidFill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F81A0F8-9563-151E-B19C-9329C51980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4881" y="1748118"/>
            <a:ext cx="4608989" cy="42760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9880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1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darnaud</dc:creator>
  <cp:lastModifiedBy>Mahaman Mourtala Issa Zakari</cp:lastModifiedBy>
  <cp:revision>2</cp:revision>
  <dcterms:created xsi:type="dcterms:W3CDTF">2023-01-02T11:39:42Z</dcterms:created>
  <dcterms:modified xsi:type="dcterms:W3CDTF">2024-10-09T18:24:27Z</dcterms:modified>
</cp:coreProperties>
</file>